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letter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4576" autoAdjust="0"/>
    <p:restoredTop sz="73643" autoAdjust="0"/>
  </p:normalViewPr>
  <p:slideViewPr>
    <p:cSldViewPr snapToGrid="0">
      <p:cViewPr>
        <p:scale>
          <a:sx n="120" d="100"/>
          <a:sy n="120" d="100"/>
        </p:scale>
        <p:origin x="-1146" y="32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22A10592-44E5-47BA-9580-2B69EF601A15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692150"/>
            <a:ext cx="259715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6"/>
            <a:ext cx="5560060" cy="41562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5810CCB8-7A1C-425B-B257-F39C5E2DF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439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76463" y="692150"/>
            <a:ext cx="2597150" cy="34639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3: </a:t>
            </a:r>
            <a:r>
              <a:rPr lang="en-US" sz="1200" b="1" dirty="0">
                <a:solidFill>
                  <a:srgbClr val="0000CC"/>
                </a:solidFill>
              </a:rPr>
              <a:t>Figures S1</a:t>
            </a:r>
            <a:r>
              <a:rPr lang="en-US" sz="1200" b="0" dirty="0">
                <a:solidFill>
                  <a:srgbClr val="0000CC"/>
                </a:solidFill>
              </a:rPr>
              <a:t>. Resuspension in 3X SSC preserved cell RNA integrity.</a:t>
            </a:r>
            <a:r>
              <a:rPr lang="en-US" sz="1200" b="0" baseline="0" dirty="0">
                <a:solidFill>
                  <a:srgbClr val="0000CC"/>
                </a:solidFill>
              </a:rPr>
              <a:t> </a:t>
            </a:r>
            <a:r>
              <a:rPr lang="en-US" sz="1200" b="1" baseline="0" dirty="0">
                <a:solidFill>
                  <a:srgbClr val="0000CC"/>
                </a:solidFill>
              </a:rPr>
              <a:t>a</a:t>
            </a:r>
            <a:r>
              <a:rPr lang="en-US" sz="1200" b="0" baseline="0" dirty="0">
                <a:solidFill>
                  <a:srgbClr val="0000CC"/>
                </a:solidFill>
              </a:rPr>
              <a:t>. The methanol-fixed PBMCs resuspended in 3X or 5X SSC buffer showed high quality of RNA determined with Bioanalyzer traces. </a:t>
            </a:r>
            <a:r>
              <a:rPr lang="en-US" sz="1200" b="1" baseline="0" dirty="0">
                <a:solidFill>
                  <a:srgbClr val="0000CC"/>
                </a:solidFill>
              </a:rPr>
              <a:t>b</a:t>
            </a:r>
            <a:r>
              <a:rPr lang="en-US" sz="1200" b="0" baseline="0" dirty="0">
                <a:solidFill>
                  <a:srgbClr val="0000CC"/>
                </a:solidFill>
              </a:rPr>
              <a:t>. The new processing method was validated in several other cell types resuspended in 3X SSC for 30min. </a:t>
            </a:r>
            <a:r>
              <a:rPr lang="en-US" sz="1200" b="0" baseline="0" dirty="0" smtClean="0">
                <a:solidFill>
                  <a:srgbClr val="0000CC"/>
                </a:solidFill>
              </a:rPr>
              <a:t>The RIN numbers were significantly </a:t>
            </a:r>
            <a:r>
              <a:rPr lang="en-US" sz="1200" b="0" baseline="0" smtClean="0">
                <a:solidFill>
                  <a:srgbClr val="0000CC"/>
                </a:solidFill>
              </a:rPr>
              <a:t>improved in </a:t>
            </a:r>
            <a:r>
              <a:rPr lang="en-US" sz="1200" b="0" baseline="0" dirty="0" smtClean="0">
                <a:solidFill>
                  <a:srgbClr val="0000CC"/>
                </a:solidFill>
              </a:rPr>
              <a:t>primary cell types and cell lines with a p value of 0.00001 and 0.008 respectively.</a:t>
            </a:r>
            <a:endParaRPr lang="en-US" sz="1200" b="0" dirty="0">
              <a:solidFill>
                <a:srgbClr val="0000CC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10CCB8-7A1C-425B-B257-F39C5E2DFB3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140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528210E-A6BF-488F-9F9E-5439BD2AB5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CEDEDF89-3B61-4354-A10A-EB97644B1D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A3DC900-999D-42D9-A130-36C5AC3E0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F2A0456-BFF8-462E-8ED4-43629CBC7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A63464C-1D96-4A43-9E55-00DF3148D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388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3B721E2-959C-4F50-87D3-4D623DD9D7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0F64F0D5-F2B8-4C93-B868-193D72C93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734B0DF-850E-4020-B5E4-F95EE26D4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9743E41-FCA1-4FEA-BEB0-74399EB96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4F4C7F1-CE3C-4E45-ABCF-84DB1FBCC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116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153C5F48-6B79-48E9-B619-B596350E80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D4D6337C-BFCF-4BC2-9082-8E3E259776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81910F6-BB73-4B5A-AB78-EFF1C4B5E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D6C98EF-5BDB-4B54-BEEA-7036FC9EE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A93F9C2-7E28-44AD-85F9-80F77235B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726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3C701FF-FBD4-45DD-9419-0B127CFEC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87A86234-FF32-4F14-B290-B47940049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6330177-3FD8-49DF-8907-0A5413DE7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D724D51-8568-4984-BE2B-27EE2438A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35FF8AA-5F14-4214-88BA-320440281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4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D92DC2F-8B3B-47BD-860E-573CFF1A4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279651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314767A-7B51-455B-AD87-0D8D56D5CB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119285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555C319-A1BF-47AA-AE22-27788C930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92920CE-4E82-4F2D-87B1-39EF8C162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B56CAC2-F0EE-4882-8EAB-A1A2A3601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375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52017C7-69C7-465A-922E-C75C0ED3E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F08BD35-7980-4F28-9B9C-38DF7A24FC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C08D1E8-15BE-4A7E-8C6E-CE32972058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B7130AED-08FC-4B5F-AFA1-43147ABF4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B9F93642-8BD1-410D-86B3-BA2CBE3B0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943E619-3415-47EA-9520-AA5DA9502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52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F8DCA5-23B4-45DF-986F-465D09FE5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A368875-F10A-4AFC-AF3A-B6F3C15518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1F75383F-D594-4C77-95AC-E853F0EA6B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D0C21B08-EE1F-4DAD-A33B-3FD558BB8C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27D48FF5-8B0C-4A5C-BF4F-ACDE279B45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D79F5D03-41A9-4F1E-8BF0-E1461DF16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66AC5392-590A-4D49-B229-283F68E6D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800E14E-0AB3-47FD-94B5-4D29D8BF5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391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FD498A7-A407-46CA-BD75-B0EC64AF4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E1254BEB-F7AC-41C6-B5B6-D7691E9EF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C7C5EB91-E3A1-45CD-96B5-4E5A66951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10A92F94-4CBB-4D16-A4FB-8BFBFC002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886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3357A6CE-7613-454D-9CA0-C33B5083A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C4CCA41D-6A16-456A-B40F-9F915A7EC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CB7696F3-F528-40C6-A5CB-98FEF69FD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69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B46FC7D-F347-4378-8009-140577AB1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90191A3-A012-444A-B70E-954AAE0B60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4" y="1316567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2E328BF-853F-41B8-89FB-5AABE9CB37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BF64BDD-D5D3-4809-8464-2BF64F7C9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2B39810-A4E2-4379-BABF-04523E2EF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3EEF0FC4-994F-49C0-BD10-3269B0FC1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02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596EB2E-181B-4C1F-99EA-0405D51ED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C4A40846-E24C-4FA1-8AC5-4B1E5C59B4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4" y="1316567"/>
            <a:ext cx="3471863" cy="649816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16A3780-7DB7-46EB-A11D-5569C741D0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BEDC694-B750-43E1-9704-3F9A4C9F8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AE67ED4-265F-4EDB-9CED-ADF310B79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8924DAE-6100-427B-B3D5-CC0767347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44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4EB5440B-A00E-4516-82E4-F9FD6EA95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92487D8-6FF6-49B6-BB63-1270BE79C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CF71965-BE6B-4381-8BBB-E993A4F43A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E9632-869D-4E0F-A76F-0304B5079128}" type="datetimeFigureOut">
              <a:rPr lang="en-US" smtClean="0"/>
              <a:t>6/3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65E0914-642D-48BD-90FB-CDA007EC02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4" y="8475135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49BCB20-D03A-477B-B627-26F7A6C10E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478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emf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B6177AEB-E4F5-49A0-9BE2-F9F40CAE1C7B}"/>
              </a:ext>
            </a:extLst>
          </p:cNvPr>
          <p:cNvSpPr txBox="1"/>
          <p:nvPr/>
        </p:nvSpPr>
        <p:spPr>
          <a:xfrm>
            <a:off x="202791" y="429566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00CC"/>
                </a:solidFill>
              </a:rPr>
              <a:t>Figure </a:t>
            </a:r>
            <a:r>
              <a:rPr lang="en-US" sz="2000" b="1" dirty="0" smtClean="0">
                <a:solidFill>
                  <a:srgbClr val="0000CC"/>
                </a:solidFill>
              </a:rPr>
              <a:t>S1</a:t>
            </a:r>
            <a:endParaRPr lang="en-US" sz="2000" b="1" dirty="0">
              <a:solidFill>
                <a:srgbClr val="0000CC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7EEC7DC3-9CE9-4F67-994C-3A3562497F5A}"/>
              </a:ext>
            </a:extLst>
          </p:cNvPr>
          <p:cNvSpPr txBox="1"/>
          <p:nvPr/>
        </p:nvSpPr>
        <p:spPr>
          <a:xfrm>
            <a:off x="64554" y="2521848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00CC"/>
                </a:solidFill>
              </a:rPr>
              <a:t>b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="" xmlns:a16="http://schemas.microsoft.com/office/drawing/2014/main" id="{44AD7879-A06A-4F49-9253-A37F450008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8561" y="1059229"/>
            <a:ext cx="1705691" cy="13475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>
            <a:extLst>
              <a:ext uri="{FF2B5EF4-FFF2-40B4-BE49-F238E27FC236}">
                <a16:creationId xmlns="" xmlns:a16="http://schemas.microsoft.com/office/drawing/2014/main" id="{005F94C1-B0A4-4704-B5CB-36541FB146C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24"/>
          <a:stretch/>
        </p:blipFill>
        <p:spPr bwMode="auto">
          <a:xfrm>
            <a:off x="3334922" y="1063499"/>
            <a:ext cx="1803639" cy="1338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>
            <a:extLst>
              <a:ext uri="{FF2B5EF4-FFF2-40B4-BE49-F238E27FC236}">
                <a16:creationId xmlns="" xmlns:a16="http://schemas.microsoft.com/office/drawing/2014/main" id="{C24884C1-B825-42C6-9470-FDE556777C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48" y="958507"/>
            <a:ext cx="1625652" cy="14883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6">
            <a:extLst>
              <a:ext uri="{FF2B5EF4-FFF2-40B4-BE49-F238E27FC236}">
                <a16:creationId xmlns="" xmlns:a16="http://schemas.microsoft.com/office/drawing/2014/main" id="{7CC8CBDC-1064-4DC1-B931-08C04A1DF4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5794" y="1019125"/>
            <a:ext cx="1502158" cy="14277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AEBDAC79-59DE-41F7-B661-E69C0D111684}"/>
              </a:ext>
            </a:extLst>
          </p:cNvPr>
          <p:cNvSpPr txBox="1"/>
          <p:nvPr/>
        </p:nvSpPr>
        <p:spPr>
          <a:xfrm>
            <a:off x="698221" y="1182419"/>
            <a:ext cx="9004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CC33"/>
                </a:solidFill>
              </a:rPr>
              <a:t>1 x S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ABE29495-0683-4496-8D69-EE4DB7ACCC14}"/>
              </a:ext>
            </a:extLst>
          </p:cNvPr>
          <p:cNvSpPr txBox="1"/>
          <p:nvPr/>
        </p:nvSpPr>
        <p:spPr>
          <a:xfrm>
            <a:off x="3754661" y="1182419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3CC33"/>
                </a:solidFill>
              </a:rPr>
              <a:t>3 x SS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045C47AC-2CE9-4CA8-A337-63EFB4881E82}"/>
              </a:ext>
            </a:extLst>
          </p:cNvPr>
          <p:cNvSpPr txBox="1"/>
          <p:nvPr/>
        </p:nvSpPr>
        <p:spPr>
          <a:xfrm>
            <a:off x="2231705" y="1183738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3CC33"/>
                </a:solidFill>
              </a:rPr>
              <a:t>2 x SS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EB5CC32A-2876-415A-967B-1BEC9264F5CF}"/>
              </a:ext>
            </a:extLst>
          </p:cNvPr>
          <p:cNvSpPr txBox="1"/>
          <p:nvPr/>
        </p:nvSpPr>
        <p:spPr>
          <a:xfrm>
            <a:off x="5437957" y="1175532"/>
            <a:ext cx="855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CC33"/>
                </a:solidFill>
              </a:rPr>
              <a:t>5 x SS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82135" y="2831670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BM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04947" y="4354677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KLM1</a:t>
            </a:r>
          </a:p>
        </p:txBody>
      </p:sp>
      <p:pic>
        <p:nvPicPr>
          <p:cNvPr id="18" name="Picture 17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5794" y="3111778"/>
            <a:ext cx="1612733" cy="1266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944" y="3120208"/>
            <a:ext cx="1553850" cy="12610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1324" y="4566298"/>
            <a:ext cx="1610734" cy="1227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" name="Picture 6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129" y="4566298"/>
            <a:ext cx="1607539" cy="1205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3754661" y="5869406"/>
            <a:ext cx="546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293T</a:t>
            </a:r>
          </a:p>
        </p:txBody>
      </p:sp>
      <p:pic>
        <p:nvPicPr>
          <p:cNvPr id="24" name="Picture 6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2687" y="6125422"/>
            <a:ext cx="1649982" cy="1225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7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9079" y="6133127"/>
            <a:ext cx="1642502" cy="12571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E542F43-063B-4742-9D7A-E9C1F606C7FB}"/>
              </a:ext>
            </a:extLst>
          </p:cNvPr>
          <p:cNvSpPr txBox="1"/>
          <p:nvPr/>
        </p:nvSpPr>
        <p:spPr>
          <a:xfrm>
            <a:off x="776846" y="319667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1.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B6ED3F87-D9CA-481D-9C15-32046F91BADB}"/>
              </a:ext>
            </a:extLst>
          </p:cNvPr>
          <p:cNvSpPr txBox="1"/>
          <p:nvPr/>
        </p:nvSpPr>
        <p:spPr>
          <a:xfrm>
            <a:off x="2452296" y="3173910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8.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BBADDFB1-8027-4BC6-A96B-6BB53DEE8B88}"/>
              </a:ext>
            </a:extLst>
          </p:cNvPr>
          <p:cNvSpPr txBox="1"/>
          <p:nvPr/>
        </p:nvSpPr>
        <p:spPr>
          <a:xfrm>
            <a:off x="3897545" y="466722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7.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6588ED81-8097-4112-B9C0-53BC0C70FFD0}"/>
              </a:ext>
            </a:extLst>
          </p:cNvPr>
          <p:cNvSpPr txBox="1"/>
          <p:nvPr/>
        </p:nvSpPr>
        <p:spPr>
          <a:xfrm>
            <a:off x="5596844" y="4662455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8.9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8ECFCFC0-CE9C-4212-9D7C-0D093DA7A3E8}"/>
              </a:ext>
            </a:extLst>
          </p:cNvPr>
          <p:cNvSpPr txBox="1"/>
          <p:nvPr/>
        </p:nvSpPr>
        <p:spPr>
          <a:xfrm>
            <a:off x="5596843" y="617718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9.6</a:t>
            </a:r>
            <a:endParaRPr lang="en-US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0A668F27-9973-4F68-A03A-121438E3360D}"/>
              </a:ext>
            </a:extLst>
          </p:cNvPr>
          <p:cNvSpPr txBox="1"/>
          <p:nvPr/>
        </p:nvSpPr>
        <p:spPr>
          <a:xfrm>
            <a:off x="3976894" y="617532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7.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82135" y="4315703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8+ </a:t>
            </a:r>
          </a:p>
        </p:txBody>
      </p:sp>
      <p:pic>
        <p:nvPicPr>
          <p:cNvPr id="36" name="Picture 2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868" y="4508566"/>
            <a:ext cx="1589659" cy="13027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570" y="4566298"/>
            <a:ext cx="1640038" cy="1275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987FBD58-3364-4C6F-93B2-9405FF709C9E}"/>
              </a:ext>
            </a:extLst>
          </p:cNvPr>
          <p:cNvSpPr txBox="1"/>
          <p:nvPr/>
        </p:nvSpPr>
        <p:spPr>
          <a:xfrm>
            <a:off x="766028" y="471818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1.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A48F57D0-F90A-4C73-BF27-9C4995A58A29}"/>
              </a:ext>
            </a:extLst>
          </p:cNvPr>
          <p:cNvSpPr txBox="1"/>
          <p:nvPr/>
        </p:nvSpPr>
        <p:spPr>
          <a:xfrm>
            <a:off x="2452295" y="468469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IN=7.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7EEC7DC3-9CE9-4F67-994C-3A3562497F5A}"/>
              </a:ext>
            </a:extLst>
          </p:cNvPr>
          <p:cNvSpPr txBox="1"/>
          <p:nvPr/>
        </p:nvSpPr>
        <p:spPr>
          <a:xfrm>
            <a:off x="47141" y="819070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00CC"/>
                </a:solidFill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15640" y="2521849"/>
            <a:ext cx="23047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PBS              SSC</a:t>
            </a:r>
            <a:endParaRPr lang="en-US" sz="24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032759" y="2521848"/>
            <a:ext cx="23047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PBS              SSC</a:t>
            </a:r>
            <a:endParaRPr lang="en-US" sz="2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993" y="7709125"/>
            <a:ext cx="1598801" cy="11967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"/>
          <p:cNvSpPr txBox="1"/>
          <p:nvPr/>
        </p:nvSpPr>
        <p:spPr>
          <a:xfrm>
            <a:off x="387078" y="7475636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MSC</a:t>
            </a:r>
            <a:endParaRPr lang="en-US" sz="1400" b="1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987FBD58-3364-4C6F-93B2-9405FF709C9E}"/>
              </a:ext>
            </a:extLst>
          </p:cNvPr>
          <p:cNvSpPr txBox="1"/>
          <p:nvPr/>
        </p:nvSpPr>
        <p:spPr>
          <a:xfrm>
            <a:off x="904162" y="771884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2.1</a:t>
            </a:r>
            <a:endParaRPr lang="en-US" sz="12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5653" y="7652673"/>
            <a:ext cx="1562715" cy="1253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A48F57D0-F90A-4C73-BF27-9C4995A58A29}"/>
              </a:ext>
            </a:extLst>
          </p:cNvPr>
          <p:cNvSpPr txBox="1"/>
          <p:nvPr/>
        </p:nvSpPr>
        <p:spPr>
          <a:xfrm>
            <a:off x="2383393" y="771884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9.5</a:t>
            </a:r>
            <a:endParaRPr lang="en-US" sz="12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365" y="6001267"/>
            <a:ext cx="1629429" cy="14419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987FBD58-3364-4C6F-93B2-9405FF709C9E}"/>
              </a:ext>
            </a:extLst>
          </p:cNvPr>
          <p:cNvSpPr txBox="1"/>
          <p:nvPr/>
        </p:nvSpPr>
        <p:spPr>
          <a:xfrm>
            <a:off x="776845" y="617718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2.4</a:t>
            </a:r>
            <a:endParaRPr lang="en-US" sz="12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1859" y="5913851"/>
            <a:ext cx="1566668" cy="1495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360934" y="5759962"/>
            <a:ext cx="871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MVEC-L</a:t>
            </a:r>
            <a:endParaRPr lang="en-US" sz="1400" b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6149" y="3069319"/>
            <a:ext cx="1676537" cy="12853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A48F57D0-F90A-4C73-BF27-9C4995A58A29}"/>
              </a:ext>
            </a:extLst>
          </p:cNvPr>
          <p:cNvSpPr txBox="1"/>
          <p:nvPr/>
        </p:nvSpPr>
        <p:spPr>
          <a:xfrm>
            <a:off x="2383393" y="617532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9.4</a:t>
            </a:r>
            <a:endParaRPr lang="en-US" sz="1200" dirty="0"/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B6ED3F87-D9CA-481D-9C15-32046F91BADB}"/>
              </a:ext>
            </a:extLst>
          </p:cNvPr>
          <p:cNvSpPr txBox="1"/>
          <p:nvPr/>
        </p:nvSpPr>
        <p:spPr>
          <a:xfrm>
            <a:off x="4153765" y="313329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1.4</a:t>
            </a:r>
            <a:endParaRPr lang="en-US" sz="1200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130" y="3111778"/>
            <a:ext cx="1607538" cy="120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B6ED3F87-D9CA-481D-9C15-32046F91BADB}"/>
              </a:ext>
            </a:extLst>
          </p:cNvPr>
          <p:cNvSpPr txBox="1"/>
          <p:nvPr/>
        </p:nvSpPr>
        <p:spPr>
          <a:xfrm>
            <a:off x="5526705" y="3189492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8.1</a:t>
            </a:r>
            <a:endParaRPr lang="en-US" sz="1200" dirty="0"/>
          </a:p>
        </p:txBody>
      </p:sp>
      <p:sp>
        <p:nvSpPr>
          <p:cNvPr id="55" name="TextBox 54"/>
          <p:cNvSpPr txBox="1"/>
          <p:nvPr/>
        </p:nvSpPr>
        <p:spPr>
          <a:xfrm>
            <a:off x="3630725" y="2846983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pleen Cell</a:t>
            </a:r>
            <a:endParaRPr lang="en-US" sz="1400" b="1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0725" y="7652673"/>
            <a:ext cx="1642502" cy="11617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130" y="7674100"/>
            <a:ext cx="1607538" cy="11617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0A668F27-9973-4F68-A03A-121438E3360D}"/>
              </a:ext>
            </a:extLst>
          </p:cNvPr>
          <p:cNvSpPr txBox="1"/>
          <p:nvPr/>
        </p:nvSpPr>
        <p:spPr>
          <a:xfrm>
            <a:off x="4018257" y="771884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5.3</a:t>
            </a:r>
            <a:endParaRPr lang="en-US" sz="1200" dirty="0"/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8ECFCFC0-CE9C-4212-9D7C-0D093DA7A3E8}"/>
              </a:ext>
            </a:extLst>
          </p:cNvPr>
          <p:cNvSpPr txBox="1"/>
          <p:nvPr/>
        </p:nvSpPr>
        <p:spPr>
          <a:xfrm>
            <a:off x="5596842" y="771884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IN=9.7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3792738" y="7430133"/>
            <a:ext cx="5116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EF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453130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2</TotalTime>
  <Words>128</Words>
  <Application>Microsoft Office PowerPoint</Application>
  <PresentationFormat>Letter Paper (8.5x11 in)</PresentationFormat>
  <Paragraphs>3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Jinguo (NIH/NHLBI) [E]</dc:creator>
  <cp:lastModifiedBy>Jinguo</cp:lastModifiedBy>
  <cp:revision>371</cp:revision>
  <cp:lastPrinted>2017-12-12T19:15:44Z</cp:lastPrinted>
  <dcterms:created xsi:type="dcterms:W3CDTF">2017-10-23T18:57:37Z</dcterms:created>
  <dcterms:modified xsi:type="dcterms:W3CDTF">2018-07-01T03:02:50Z</dcterms:modified>
</cp:coreProperties>
</file>